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963699A-7BFA-4EEC-A647-C512538D3F5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6956CCD-9505-4FB5-BAB4-F068C1BA3F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AABE26A-1366-40D1-9D5C-A6682E71393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109E0D0-DAD1-42D2-A060-655AE830FEF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FC3DFB3-28D6-4E5E-8F2A-15F6FFCAF6D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8FB6356-6D3B-4CDA-ABFE-1A2C535CD3B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42A5C20-E844-44E8-BBDA-0FBE92D47FA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EBFF737-CB49-44FD-B87B-98DE2A3D3F8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10CB922-B2FD-4C66-B840-38B4100668F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0A1DDE-C4E3-4E22-A59B-23CD4A14208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16FBEC-E7E0-464A-86A8-F0054247B36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C1C61D-3162-4C4A-AC2E-2E8B9133A60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6C48161-BF18-480A-B105-80D4FECF242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png"/><Relationship Id="rId3"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1596960" y="333360"/>
          <a:ext cx="5950080" cy="4506840"/>
        </p:xfrm>
        <a:graphic>
          <a:graphicData uri="http://schemas.openxmlformats.org/presentationml/2006/ole">
            <p:oleObj progId="Excel.Sheet.12" r:id="rId1" spid="">
              <p:embed/>
              <p:pic>
                <p:nvPicPr>
                  <p:cNvPr id="42" name="" descr=""/>
                  <p:cNvPicPr/>
                  <p:nvPr/>
                </p:nvPicPr>
                <p:blipFill>
                  <a:blip r:embed="rId2"/>
                  <a:stretch/>
                </p:blipFill>
                <p:spPr>
                  <a:xfrm>
                    <a:off x="1596960" y="333360"/>
                    <a:ext cx="5950080" cy="4506840"/>
                  </a:xfrm>
                  <a:prstGeom prst="rect">
                    <a:avLst/>
                  </a:prstGeom>
                  <a:ln w="0">
                    <a:noFill/>
                  </a:ln>
                </p:spPr>
              </p:pic>
            </p:oleObj>
          </a:graphicData>
        </a:graphic>
      </p:graphicFrame>
      <p:sp>
        <p:nvSpPr>
          <p:cNvPr id="43" name=""/>
          <p:cNvSpPr/>
          <p:nvPr/>
        </p:nvSpPr>
        <p:spPr>
          <a:xfrm>
            <a:off x="1835280" y="4777200"/>
            <a:ext cx="4968720" cy="1675440"/>
          </a:xfrm>
          <a:prstGeom prst="rect">
            <a:avLst/>
          </a:prstGeom>
          <a:noFill/>
          <a:ln w="0">
            <a:noFill/>
          </a:ln>
        </p:spPr>
        <p:style>
          <a:lnRef idx="0"/>
          <a:fillRef idx="0"/>
          <a:effectRef idx="0"/>
          <a:fontRef idx="minor"/>
        </p:style>
        <p:txBody>
          <a:bodyPr lIns="90000" rIns="90000" tIns="15228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1: ABCG2 mRNA levels in human and murine prostate tumor cell lines negatively correlate with PpIX accumulation</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he amount of ABCG2 mRNA was determined by oligonucleotide microarray analyses in human (PC-3) and murine prostate cancer cell lines (TRAMP-C1, TRAMP-C2) as well as in subcutaneously grown murine prostate tumors (TRAMP-C2). As a control, the expression of the house keeping gene encoding the TATA-box-binding protein (TBP) is show. Note the high levels of expression of the PpIX exporter ABCG2 in murine prostate cancer cells which inversely correlates with their ability to accumulate PpIX in the presence of 5‑ALA (see Fig. 1A, C; Fig. 6B, C). Mean and (standard) deviations are shown. n=2 for murine cells, n=3 for PC-3.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0-08T15:46:43Z</dcterms:created>
  <dc:creator>Prof. W. Zimmermann</dc:creator>
  <dc:description/>
  <dc:language>en-US</dc:language>
  <cp:lastModifiedBy>Prof. W. Zimmermann</cp:lastModifiedBy>
  <dcterms:modified xsi:type="dcterms:W3CDTF">2011-05-06T12:19:47Z</dcterms:modified>
  <cp:revision>11</cp:revision>
  <dc:subject/>
  <dc:title>Folie 1</dc:title>
</cp:coreProperties>
</file>